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129D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6" autoAdjust="0"/>
    <p:restoredTop sz="94660"/>
  </p:normalViewPr>
  <p:slideViewPr>
    <p:cSldViewPr snapToGrid="0">
      <p:cViewPr>
        <p:scale>
          <a:sx n="100" d="100"/>
          <a:sy n="100" d="100"/>
        </p:scale>
        <p:origin x="2058" y="-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4B1C-238E-4664-8AE7-38A6F52D2684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694CE-AB10-4D01-BAD0-04C43D56ED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573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4B1C-238E-4664-8AE7-38A6F52D2684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694CE-AB10-4D01-BAD0-04C43D56ED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5466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4B1C-238E-4664-8AE7-38A6F52D2684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694CE-AB10-4D01-BAD0-04C43D56ED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972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4B1C-238E-4664-8AE7-38A6F52D2684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694CE-AB10-4D01-BAD0-04C43D56ED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705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4B1C-238E-4664-8AE7-38A6F52D2684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694CE-AB10-4D01-BAD0-04C43D56ED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884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4B1C-238E-4664-8AE7-38A6F52D2684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694CE-AB10-4D01-BAD0-04C43D56ED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861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4B1C-238E-4664-8AE7-38A6F52D2684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694CE-AB10-4D01-BAD0-04C43D56ED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140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4B1C-238E-4664-8AE7-38A6F52D2684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694CE-AB10-4D01-BAD0-04C43D56ED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012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4B1C-238E-4664-8AE7-38A6F52D2684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694CE-AB10-4D01-BAD0-04C43D56ED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0863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4B1C-238E-4664-8AE7-38A6F52D2684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694CE-AB10-4D01-BAD0-04C43D56ED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577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4B1C-238E-4664-8AE7-38A6F52D2684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694CE-AB10-4D01-BAD0-04C43D56ED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743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5C4B1C-238E-4664-8AE7-38A6F52D2684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C694CE-AB10-4D01-BAD0-04C43D56ED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921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xmlns="" id="{B02DAC90-6E33-4A42-BF97-5BE2824280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4472966"/>
              </p:ext>
            </p:extLst>
          </p:nvPr>
        </p:nvGraphicFramePr>
        <p:xfrm>
          <a:off x="962237" y="1241881"/>
          <a:ext cx="2415739" cy="21945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2" name="Prism 7" r:id="rId3" imgW="2669781" imgH="2425781" progId="Prism7.Document">
                  <p:embed/>
                </p:oleObj>
              </mc:Choice>
              <mc:Fallback>
                <p:oleObj name="Prism 7" r:id="rId3" imgW="2669781" imgH="2425781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62237" y="1241881"/>
                        <a:ext cx="2415739" cy="21945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AEAD0031-6CCB-4980-B3AD-6A62EAD541A7}"/>
              </a:ext>
            </a:extLst>
          </p:cNvPr>
          <p:cNvSpPr txBox="1"/>
          <p:nvPr/>
        </p:nvSpPr>
        <p:spPr>
          <a:xfrm>
            <a:off x="1767612" y="3313331"/>
            <a:ext cx="11857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Time (days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7">
            <a:extLst>
              <a:ext uri="{FF2B5EF4-FFF2-40B4-BE49-F238E27FC236}">
                <a16:creationId xmlns:a16="http://schemas.microsoft.com/office/drawing/2014/main" xmlns="" id="{A2426EE9-8F3B-4C32-A273-2C201290915F}"/>
              </a:ext>
            </a:extLst>
          </p:cNvPr>
          <p:cNvSpPr txBox="1"/>
          <p:nvPr/>
        </p:nvSpPr>
        <p:spPr>
          <a:xfrm rot="16200000">
            <a:off x="444266" y="2186721"/>
            <a:ext cx="1035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Survival (%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3B203A0D-B52F-4F57-97AF-C388D3827FCC}"/>
              </a:ext>
            </a:extLst>
          </p:cNvPr>
          <p:cNvSpPr txBox="1"/>
          <p:nvPr/>
        </p:nvSpPr>
        <p:spPr>
          <a:xfrm>
            <a:off x="1627857" y="1007435"/>
            <a:ext cx="1823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Overall survival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2209E103-5797-4B93-9FCD-FAC14D4217EA}"/>
              </a:ext>
            </a:extLst>
          </p:cNvPr>
          <p:cNvSpPr txBox="1"/>
          <p:nvPr/>
        </p:nvSpPr>
        <p:spPr>
          <a:xfrm>
            <a:off x="2130471" y="2477730"/>
            <a:ext cx="11857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cs typeface="Arial" pitchFamily="34" charset="0"/>
              </a:rPr>
              <a:t>P=0.6068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xmlns="" id="{E95CB77F-28D2-4695-8693-E1F63480F083}"/>
              </a:ext>
            </a:extLst>
          </p:cNvPr>
          <p:cNvCxnSpPr/>
          <p:nvPr/>
        </p:nvCxnSpPr>
        <p:spPr>
          <a:xfrm>
            <a:off x="1731072" y="1796985"/>
            <a:ext cx="238125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xmlns="" id="{E00EA681-A01D-42DA-BD45-E86EDAA2DC87}"/>
              </a:ext>
            </a:extLst>
          </p:cNvPr>
          <p:cNvCxnSpPr/>
          <p:nvPr/>
        </p:nvCxnSpPr>
        <p:spPr>
          <a:xfrm>
            <a:off x="1735470" y="1548688"/>
            <a:ext cx="238125" cy="0"/>
          </a:xfrm>
          <a:prstGeom prst="line">
            <a:avLst/>
          </a:prstGeom>
          <a:ln w="19050">
            <a:solidFill>
              <a:srgbClr val="2129D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F499D1C9-7EFC-47CD-9EDA-EBF17A5B2F18}"/>
              </a:ext>
            </a:extLst>
          </p:cNvPr>
          <p:cNvSpPr txBox="1"/>
          <p:nvPr/>
        </p:nvSpPr>
        <p:spPr>
          <a:xfrm>
            <a:off x="1969196" y="1673874"/>
            <a:ext cx="13810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cs typeface="Arial" pitchFamily="34" charset="0"/>
              </a:rPr>
              <a:t>High PD-1% (n=10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CBBE0B3E-0FB1-497E-933D-D919702634E4}"/>
              </a:ext>
            </a:extLst>
          </p:cNvPr>
          <p:cNvSpPr txBox="1"/>
          <p:nvPr/>
        </p:nvSpPr>
        <p:spPr>
          <a:xfrm>
            <a:off x="1969196" y="1427653"/>
            <a:ext cx="1617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cs typeface="Arial" pitchFamily="34" charset="0"/>
              </a:rPr>
              <a:t>Low PD-1% (n=11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A914F425-D8BA-406B-BE64-E909F3F7DD1C}"/>
              </a:ext>
            </a:extLst>
          </p:cNvPr>
          <p:cNvSpPr txBox="1"/>
          <p:nvPr/>
        </p:nvSpPr>
        <p:spPr>
          <a:xfrm>
            <a:off x="784631" y="723610"/>
            <a:ext cx="534183" cy="2871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2D7DB6B7-3C1F-4864-A7DC-09CCF3A69BA2}"/>
              </a:ext>
            </a:extLst>
          </p:cNvPr>
          <p:cNvSpPr txBox="1"/>
          <p:nvPr/>
        </p:nvSpPr>
        <p:spPr>
          <a:xfrm>
            <a:off x="3971505" y="723609"/>
            <a:ext cx="534183" cy="2871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A9884814-F1F2-46E7-8C2E-085F19164B82}"/>
              </a:ext>
            </a:extLst>
          </p:cNvPr>
          <p:cNvSpPr txBox="1"/>
          <p:nvPr/>
        </p:nvSpPr>
        <p:spPr>
          <a:xfrm>
            <a:off x="4286372" y="3130010"/>
            <a:ext cx="11857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cs typeface="Arial" pitchFamily="34" charset="0"/>
              </a:rPr>
              <a:t>Low PD-1%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1A8DD08D-3141-4D6C-ADA3-A7D790E06157}"/>
              </a:ext>
            </a:extLst>
          </p:cNvPr>
          <p:cNvSpPr txBox="1"/>
          <p:nvPr/>
        </p:nvSpPr>
        <p:spPr>
          <a:xfrm>
            <a:off x="5032340" y="3130010"/>
            <a:ext cx="11857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cs typeface="Arial" pitchFamily="34" charset="0"/>
              </a:rPr>
              <a:t>high PD-1%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7">
            <a:extLst>
              <a:ext uri="{FF2B5EF4-FFF2-40B4-BE49-F238E27FC236}">
                <a16:creationId xmlns:a16="http://schemas.microsoft.com/office/drawing/2014/main" xmlns="" id="{3A25D814-32A0-42F5-B108-DA62320829B5}"/>
              </a:ext>
            </a:extLst>
          </p:cNvPr>
          <p:cNvSpPr txBox="1"/>
          <p:nvPr/>
        </p:nvSpPr>
        <p:spPr>
          <a:xfrm rot="16200000">
            <a:off x="3308428" y="2176919"/>
            <a:ext cx="17657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Complete remission (%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291385A9-CEDB-41CF-B423-55DBF7EA6607}"/>
              </a:ext>
            </a:extLst>
          </p:cNvPr>
          <p:cNvSpPr txBox="1"/>
          <p:nvPr/>
        </p:nvSpPr>
        <p:spPr>
          <a:xfrm>
            <a:off x="4657519" y="1401065"/>
            <a:ext cx="4244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8/9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6DBA8850-BDD2-4446-AF2C-133882FB237D}"/>
              </a:ext>
            </a:extLst>
          </p:cNvPr>
          <p:cNvSpPr txBox="1"/>
          <p:nvPr/>
        </p:nvSpPr>
        <p:spPr>
          <a:xfrm>
            <a:off x="5100997" y="1935584"/>
            <a:ext cx="581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5/9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2694A288-24F4-4239-9A3B-E543EA8C69DB}"/>
              </a:ext>
            </a:extLst>
          </p:cNvPr>
          <p:cNvSpPr txBox="1"/>
          <p:nvPr/>
        </p:nvSpPr>
        <p:spPr>
          <a:xfrm>
            <a:off x="4725531" y="1087037"/>
            <a:ext cx="11857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cs typeface="Arial" pitchFamily="34" charset="0"/>
              </a:rPr>
              <a:t>P=0.114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xmlns="" id="{9B9FFD33-1332-4C8C-B547-DBCA83B6945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398850"/>
              </p:ext>
            </p:extLst>
          </p:nvPr>
        </p:nvGraphicFramePr>
        <p:xfrm>
          <a:off x="4179254" y="1241881"/>
          <a:ext cx="1518329" cy="21945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3" name="Prism 7" r:id="rId5" imgW="1700424" imgH="2457818" progId="Prism7.Document">
                  <p:embed/>
                </p:oleObj>
              </mc:Choice>
              <mc:Fallback>
                <p:oleObj name="Prism 7" r:id="rId5" imgW="1700424" imgH="245781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79254" y="1241881"/>
                        <a:ext cx="1518329" cy="21945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2" name="Group 11">
            <a:extLst>
              <a:ext uri="{FF2B5EF4-FFF2-40B4-BE49-F238E27FC236}">
                <a16:creationId xmlns:a16="http://schemas.microsoft.com/office/drawing/2014/main" xmlns="" id="{2A9B20A5-B969-4293-93AA-859A130EA244}"/>
              </a:ext>
            </a:extLst>
          </p:cNvPr>
          <p:cNvGrpSpPr/>
          <p:nvPr/>
        </p:nvGrpSpPr>
        <p:grpSpPr>
          <a:xfrm>
            <a:off x="4830404" y="1325718"/>
            <a:ext cx="457200" cy="91440"/>
            <a:chOff x="1156855" y="4050596"/>
            <a:chExt cx="562184" cy="133477"/>
          </a:xfrm>
        </p:grpSpPr>
        <p:cxnSp>
          <p:nvCxnSpPr>
            <p:cNvPr id="4" name="Straight Connector 3">
              <a:extLst>
                <a:ext uri="{FF2B5EF4-FFF2-40B4-BE49-F238E27FC236}">
                  <a16:creationId xmlns:a16="http://schemas.microsoft.com/office/drawing/2014/main" xmlns="" id="{C0F9429F-8795-453A-A5FD-83DDAB9CD907}"/>
                </a:ext>
              </a:extLst>
            </p:cNvPr>
            <p:cNvCxnSpPr/>
            <p:nvPr/>
          </p:nvCxnSpPr>
          <p:spPr>
            <a:xfrm>
              <a:off x="1156855" y="4050596"/>
              <a:ext cx="0" cy="13347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xmlns="" id="{B61C758A-BFCB-4528-BFAE-03A2A4270574}"/>
                </a:ext>
              </a:extLst>
            </p:cNvPr>
            <p:cNvCxnSpPr/>
            <p:nvPr/>
          </p:nvCxnSpPr>
          <p:spPr>
            <a:xfrm>
              <a:off x="1719039" y="4050596"/>
              <a:ext cx="0" cy="13347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xmlns="" id="{E230905F-E7E9-48F9-AF2B-2D61DB3DD13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60547" y="4053158"/>
              <a:ext cx="55849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TextBox 2"/>
          <p:cNvSpPr txBox="1"/>
          <p:nvPr/>
        </p:nvSpPr>
        <p:spPr>
          <a:xfrm>
            <a:off x="784631" y="3925440"/>
            <a:ext cx="534946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Figure 1. Correlation between the PD-1 expression </a:t>
            </a:r>
            <a:r>
              <a:rPr lang="en-US" sz="1200" b="1" dirty="0" smtClean="0"/>
              <a:t>on </a:t>
            </a:r>
            <a:r>
              <a:rPr lang="en-US" sz="1200" b="1" dirty="0"/>
              <a:t>bone marrow CD8 T cells and clinical outcome. </a:t>
            </a:r>
            <a:r>
              <a:rPr lang="en-US" sz="1200" b="1" dirty="0" smtClean="0"/>
              <a:t> </a:t>
            </a:r>
            <a:r>
              <a:rPr lang="en-US" sz="1200" dirty="0" smtClean="0"/>
              <a:t>AML patients in our study (n=22) were </a:t>
            </a:r>
            <a:r>
              <a:rPr lang="en-US" sz="1200" dirty="0"/>
              <a:t>divided into high-PD-1 vs. low-PD-1 subgroups by using the median value of PD-1 expression </a:t>
            </a:r>
            <a:r>
              <a:rPr lang="en-US" sz="1200" dirty="0" smtClean="0"/>
              <a:t>on </a:t>
            </a:r>
            <a:r>
              <a:rPr lang="en-US" sz="1200" dirty="0"/>
              <a:t>bone marrow CD8 T cells. The </a:t>
            </a:r>
            <a:r>
              <a:rPr lang="en-US" sz="1200" dirty="0" smtClean="0"/>
              <a:t>analysis </a:t>
            </a:r>
            <a:r>
              <a:rPr lang="en-US" sz="1200" dirty="0"/>
              <a:t>of overall survival (a) and the rate of complete remission (CR) after induction treatment (b) </a:t>
            </a:r>
            <a:r>
              <a:rPr lang="en-US" sz="1200" dirty="0" smtClean="0"/>
              <a:t>comparing the </a:t>
            </a:r>
            <a:r>
              <a:rPr lang="en-US" sz="1200" dirty="0"/>
              <a:t>high-PD-1 </a:t>
            </a:r>
            <a:r>
              <a:rPr lang="en-US" sz="1200" dirty="0" smtClean="0"/>
              <a:t>vs. low-PD-1 </a:t>
            </a:r>
            <a:r>
              <a:rPr lang="en-US" sz="1200" dirty="0"/>
              <a:t>subgroups </a:t>
            </a:r>
            <a:r>
              <a:rPr lang="en-US" sz="1200" dirty="0" smtClean="0"/>
              <a:t>is shown.</a:t>
            </a:r>
            <a:r>
              <a:rPr lang="en-US" sz="1200" b="1" dirty="0" smtClean="0"/>
              <a:t> </a:t>
            </a:r>
            <a:r>
              <a:rPr lang="en-US" sz="1200" dirty="0"/>
              <a:t>Among </a:t>
            </a:r>
            <a:r>
              <a:rPr lang="en-US" sz="1200" dirty="0" smtClean="0"/>
              <a:t>the 22 </a:t>
            </a:r>
            <a:r>
              <a:rPr lang="en-US" sz="1200" dirty="0"/>
              <a:t>patients</a:t>
            </a:r>
            <a:r>
              <a:rPr lang="en-US" sz="1200" dirty="0" smtClean="0"/>
              <a:t>, data were available to assess for overall survival in 21 patients, for remission status in 18 patients. </a:t>
            </a:r>
            <a:r>
              <a:rPr lang="en-US" sz="1200" i="1" dirty="0" smtClean="0"/>
              <a:t>P</a:t>
            </a:r>
            <a:r>
              <a:rPr lang="en-US" sz="1200" dirty="0" smtClean="0"/>
              <a:t> </a:t>
            </a:r>
            <a:r>
              <a:rPr lang="en-US" sz="1200" dirty="0"/>
              <a:t>value was obtained by Log-rank test and Fisher’s exact test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576125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</TotalTime>
  <Words>154</Words>
  <Application>Microsoft Office PowerPoint</Application>
  <PresentationFormat>A4 Paper (210x297 mm)</PresentationFormat>
  <Paragraphs>1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等线</vt:lpstr>
      <vt:lpstr>Office Theme</vt:lpstr>
      <vt:lpstr>Prism 7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beibj@163.com</dc:creator>
  <cp:lastModifiedBy>Hong Zheng</cp:lastModifiedBy>
  <cp:revision>13</cp:revision>
  <dcterms:created xsi:type="dcterms:W3CDTF">2018-01-09T20:51:44Z</dcterms:created>
  <dcterms:modified xsi:type="dcterms:W3CDTF">2018-01-10T15:00:41Z</dcterms:modified>
</cp:coreProperties>
</file>